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80" r:id="rId2"/>
  </p:sldIdLst>
  <p:sldSz cx="9144000" cy="6858000" type="screen4x3"/>
  <p:notesSz cx="6797675" cy="99282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132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DF029D-EDCB-45D5-A052-179015136C68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D082A5-A52B-4BD4-A57C-9841B6685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0798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347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433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270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301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2012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030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599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58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358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4059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03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FB805-0004-4882-88AF-039BE33E20FD}" type="datetimeFigureOut">
              <a:rPr kumimoji="1" lang="ja-JP" altLang="en-US" smtClean="0"/>
              <a:t>2018/5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607E9-2C41-4A22-8A25-C1DDCDDDC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7529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852669" y="6028681"/>
            <a:ext cx="3953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ry Fig.1 Yokawa et al., 2018</a:t>
            </a:r>
            <a:endParaRPr kumimoji="1" lang="ja-JP" altLang="en-US" dirty="0"/>
          </a:p>
        </p:txBody>
      </p:sp>
      <p:sp>
        <p:nvSpPr>
          <p:cNvPr id="2" name="正方形/長方形 1"/>
          <p:cNvSpPr/>
          <p:nvPr/>
        </p:nvSpPr>
        <p:spPr>
          <a:xfrm>
            <a:off x="1585504" y="1783276"/>
            <a:ext cx="3878840" cy="26571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M  L  G  N  K  R  L  G  L  S  G  L  T  L (14)</a:t>
            </a: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ATGCTGGGCAACAAGAGACTGGGCCTGAGCGGCCTGACCCTG</a:t>
            </a:r>
            <a:r>
              <a:rPr lang="ja-JP" altLang="en-US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</a:t>
            </a: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ja-JP" altLang="en-US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A 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L 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S  L 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L  V  C  L  G  A  L 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A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E  A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(28)</a:t>
            </a:r>
          </a:p>
          <a:p>
            <a:pPr algn="just">
              <a:lnSpc>
                <a:spcPts val="1000"/>
              </a:lnSpc>
            </a:pPr>
            <a:r>
              <a:rPr lang="en-US" altLang="ja-JP" sz="1000" i="1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GCCCTGAGCCTGCTGGTGTGCCTGGGCGCCCTG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GCCGAGGCC</a:t>
            </a: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Y  P  S  K  P  D  N  P  G  E  D  A  P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A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(42)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TACCCCAGCAAGCCCGACAACCCCGGCGAGGACGCCCCCGCC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E  D 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M  A  R  Y  </a:t>
            </a:r>
            <a:r>
              <a:rPr lang="en-US" altLang="ja-JP" sz="1000" kern="0" dirty="0" err="1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Y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S 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A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L  R  H  Y  I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(56)</a:t>
            </a:r>
          </a:p>
          <a:p>
            <a:pPr algn="just">
              <a:lnSpc>
                <a:spcPts val="1000"/>
              </a:lnSpc>
            </a:pPr>
            <a:r>
              <a:rPr lang="en-US" altLang="ja-JP" sz="1000" i="1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GAGGACATGGCCAGATACTACAGC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GCCCTGAGACACTACATC</a:t>
            </a:r>
          </a:p>
          <a:p>
            <a:pPr algn="just">
              <a:lnSpc>
                <a:spcPts val="1000"/>
              </a:lnSpc>
            </a:pP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N  L  I  T  R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Q  R  Y  G  K  R  S  </a:t>
            </a:r>
            <a:r>
              <a:rPr lang="en-US" altLang="ja-JP" sz="1000" kern="0" dirty="0" err="1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S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P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(70)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AACCTGATCACCAGACAGAGATACGGCAAGAGAAGCAGCCCC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endParaRPr lang="en-US" altLang="ja-JP" sz="1000" kern="0" dirty="0" smtClean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E 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T  L  I  S  D  L  </a:t>
            </a:r>
            <a:r>
              <a:rPr lang="en-US" altLang="ja-JP" sz="1000" kern="0" dirty="0" err="1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L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M  R  E  S  T  E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(84)</a:t>
            </a: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GAGACCCTGATCAGCGACCTGCTGATGAGAGAGAGCACCGAG</a:t>
            </a:r>
            <a:endParaRPr lang="en-US" altLang="ja-JP" sz="1000" kern="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</a:t>
            </a: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N  V  </a:t>
            </a:r>
            <a:r>
              <a:rPr lang="en-US" altLang="ja-JP" sz="1000" kern="0" dirty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P  R  T  R  L  E  D  P  A  M  W </a:t>
            </a: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  (97)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  <a:p>
            <a:pPr algn="just">
              <a:lnSpc>
                <a:spcPts val="1000"/>
              </a:lnSpc>
            </a:pPr>
            <a:r>
              <a:rPr lang="en-US" altLang="ja-JP" sz="1000" kern="0" dirty="0" smtClean="0">
                <a:latin typeface="Courier New" panose="02070309020205020404" pitchFamily="49" charset="0"/>
                <a:ea typeface="ＭＳ 明朝" panose="02020609040205080304" pitchFamily="17" charset="-128"/>
                <a:cs typeface="Courier New" panose="02070309020205020404" pitchFamily="49" charset="0"/>
              </a:rPr>
              <a:t> AACGTGCCCAGAACCAGACTGGAGGACCCCGCCATGTGG</a:t>
            </a:r>
            <a:endParaRPr lang="ja-JP" altLang="ja-JP" sz="1000" kern="100" dirty="0">
              <a:latin typeface="Courier New" panose="02070309020205020404" pitchFamily="49" charset="0"/>
              <a:ea typeface="ＭＳ 明朝" panose="02020609040205080304" pitchFamily="17" charset="-128"/>
              <a:cs typeface="Courier New" panose="02070309020205020404" pitchFamily="49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924783" y="1787683"/>
            <a:ext cx="1401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cDNA3-pGLuc-pN</a:t>
            </a:r>
          </a:p>
        </p:txBody>
      </p:sp>
      <p:cxnSp>
        <p:nvCxnSpPr>
          <p:cNvPr id="16" name="直線矢印コネクタ 15"/>
          <p:cNvCxnSpPr/>
          <p:nvPr/>
        </p:nvCxnSpPr>
        <p:spPr>
          <a:xfrm flipH="1">
            <a:off x="6592973" y="2109439"/>
            <a:ext cx="0" cy="79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6214541" y="3470604"/>
            <a:ext cx="97013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cDNA3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PY</a:t>
            </a:r>
            <a:endParaRPr kumimoji="1" lang="en-US" altLang="ja-JP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pGLuc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152544" y="3040984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PY</a:t>
            </a:r>
            <a:endParaRPr kumimoji="1" lang="ja-JP" alt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6976286" y="3161780"/>
            <a:ext cx="5822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uc</a:t>
            </a:r>
            <a:endParaRPr kumimoji="1" lang="ja-JP" alt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764190" y="3218435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</a:t>
            </a:r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II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円弧 28"/>
          <p:cNvSpPr>
            <a:spLocks noChangeAspect="1"/>
          </p:cNvSpPr>
          <p:nvPr/>
        </p:nvSpPr>
        <p:spPr>
          <a:xfrm rot="784156">
            <a:off x="6160616" y="3270622"/>
            <a:ext cx="1080000" cy="1080000"/>
          </a:xfrm>
          <a:prstGeom prst="arc">
            <a:avLst>
              <a:gd name="adj1" fmla="val 15323393"/>
              <a:gd name="adj2" fmla="val 20089908"/>
            </a:avLst>
          </a:prstGeom>
          <a:ln w="571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円弧 29"/>
          <p:cNvSpPr>
            <a:spLocks noChangeAspect="1"/>
          </p:cNvSpPr>
          <p:nvPr/>
        </p:nvSpPr>
        <p:spPr>
          <a:xfrm rot="850352">
            <a:off x="6157204" y="3270622"/>
            <a:ext cx="1080000" cy="1080000"/>
          </a:xfrm>
          <a:prstGeom prst="arc">
            <a:avLst>
              <a:gd name="adj1" fmla="val 20060327"/>
              <a:gd name="adj2" fmla="val 1258898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円弧 30"/>
          <p:cNvSpPr>
            <a:spLocks noChangeAspect="1"/>
          </p:cNvSpPr>
          <p:nvPr/>
        </p:nvSpPr>
        <p:spPr>
          <a:xfrm rot="851907">
            <a:off x="6157204" y="3270622"/>
            <a:ext cx="1080000" cy="1080000"/>
          </a:xfrm>
          <a:prstGeom prst="arc">
            <a:avLst>
              <a:gd name="adj1" fmla="val 12580660"/>
              <a:gd name="adj2" fmla="val 15298864"/>
            </a:avLst>
          </a:prstGeom>
          <a:ln w="5715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 rot="1020000">
            <a:off x="6195632" y="3357789"/>
            <a:ext cx="14400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 flipH="1">
            <a:off x="6686525" y="3118560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6586182" y="2923334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</a:t>
            </a:r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054494" y="2280660"/>
            <a:ext cx="1080000" cy="3773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993690" y="2249480"/>
            <a:ext cx="1215397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PY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</a:t>
            </a:r>
            <a:r>
              <a:rPr lang="en-US" altLang="ja-JP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II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ja-JP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</a:t>
            </a:r>
            <a:r>
              <a:rPr lang="en-US" altLang="ja-JP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635186" y="148404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471543" y="14840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619624" y="5013416"/>
            <a:ext cx="50321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AAGCTT</a:t>
            </a:r>
            <a:r>
              <a:rPr kumimoji="1" lang="ja-JP" alt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CACC </a:t>
            </a:r>
            <a:r>
              <a:rPr kumimoji="1" lang="en-US" altLang="ja-JP" sz="10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-TGG GAA TTC AAG------GAC </a:t>
            </a:r>
            <a:r>
              <a:rPr kumimoji="1" lang="en-US" altLang="ja-JP" sz="10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A</a:t>
            </a:r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CT AGA</a:t>
            </a:r>
            <a:endParaRPr kumimoji="1" lang="ja-JP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635186" y="45269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/>
          <p:cNvCxnSpPr/>
          <p:nvPr/>
        </p:nvCxnSpPr>
        <p:spPr>
          <a:xfrm>
            <a:off x="1775852" y="5222757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4067736" y="5222757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4665019" y="5222757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5987327" y="5222757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2866008" y="5222757"/>
            <a:ext cx="11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1779383" y="5206283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I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227362" y="5206283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PY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093118" y="5206283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888401" y="5206283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6047566" y="5206283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</a:t>
            </a:r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056607" y="486531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F</a:t>
            </a:r>
            <a:endParaRPr kumimoji="1" lang="ja-JP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661525" y="4865315"/>
            <a:ext cx="954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  -  -  W</a:t>
            </a:r>
            <a:endParaRPr kumimoji="1" lang="ja-JP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2" name="グループ化 11"/>
          <p:cNvGrpSpPr/>
          <p:nvPr/>
        </p:nvGrpSpPr>
        <p:grpSpPr>
          <a:xfrm>
            <a:off x="2847608" y="4880649"/>
            <a:ext cx="1152000" cy="73233"/>
            <a:chOff x="2831888" y="4214619"/>
            <a:chExt cx="1152000" cy="73233"/>
          </a:xfrm>
        </p:grpSpPr>
        <p:cxnSp>
          <p:nvCxnSpPr>
            <p:cNvPr id="11" name="直線コネクタ 10"/>
            <p:cNvCxnSpPr/>
            <p:nvPr/>
          </p:nvCxnSpPr>
          <p:spPr>
            <a:xfrm flipH="1">
              <a:off x="3981958" y="4214619"/>
              <a:ext cx="0" cy="7200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/>
            <p:cNvCxnSpPr/>
            <p:nvPr/>
          </p:nvCxnSpPr>
          <p:spPr>
            <a:xfrm flipH="1">
              <a:off x="2831888" y="4215852"/>
              <a:ext cx="0" cy="7200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/>
            <p:cNvCxnSpPr/>
            <p:nvPr/>
          </p:nvCxnSpPr>
          <p:spPr>
            <a:xfrm>
              <a:off x="2831888" y="4214619"/>
              <a:ext cx="1152000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グループ化 48"/>
          <p:cNvGrpSpPr/>
          <p:nvPr/>
        </p:nvGrpSpPr>
        <p:grpSpPr>
          <a:xfrm>
            <a:off x="4668173" y="4861784"/>
            <a:ext cx="936000" cy="73233"/>
            <a:chOff x="2831888" y="4214619"/>
            <a:chExt cx="1152000" cy="73233"/>
          </a:xfrm>
        </p:grpSpPr>
        <p:cxnSp>
          <p:nvCxnSpPr>
            <p:cNvPr id="50" name="直線コネクタ 49"/>
            <p:cNvCxnSpPr/>
            <p:nvPr/>
          </p:nvCxnSpPr>
          <p:spPr>
            <a:xfrm flipH="1">
              <a:off x="3981958" y="4214619"/>
              <a:ext cx="0" cy="7200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/>
            <p:cNvCxnSpPr/>
            <p:nvPr/>
          </p:nvCxnSpPr>
          <p:spPr>
            <a:xfrm flipH="1">
              <a:off x="2831888" y="4215852"/>
              <a:ext cx="0" cy="7200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/>
            <p:cNvCxnSpPr/>
            <p:nvPr/>
          </p:nvCxnSpPr>
          <p:spPr>
            <a:xfrm>
              <a:off x="2831888" y="4214619"/>
              <a:ext cx="1152000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テキスト ボックス 52"/>
          <p:cNvSpPr txBox="1"/>
          <p:nvPr/>
        </p:nvSpPr>
        <p:spPr>
          <a:xfrm>
            <a:off x="2846041" y="4861784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  -  -  -  W</a:t>
            </a:r>
            <a:endParaRPr kumimoji="1" lang="ja-JP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001173" y="4680939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PY (97aa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4661525" y="4678246"/>
            <a:ext cx="8739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ase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168aa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9700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44</TotalTime>
  <Words>180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明朝</vt:lpstr>
      <vt:lpstr>游ゴシック</vt:lpstr>
      <vt:lpstr>游ゴシック Light</vt:lpstr>
      <vt:lpstr>Arial</vt:lpstr>
      <vt:lpstr>Calibri</vt:lpstr>
      <vt:lpstr>Calibri Light</vt:lpstr>
      <vt:lpstr>Courier New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kawa</dc:creator>
  <cp:lastModifiedBy>furuno</cp:lastModifiedBy>
  <cp:revision>156</cp:revision>
  <cp:lastPrinted>2018-05-24T01:40:16Z</cp:lastPrinted>
  <dcterms:created xsi:type="dcterms:W3CDTF">2017-11-13T10:59:48Z</dcterms:created>
  <dcterms:modified xsi:type="dcterms:W3CDTF">2018-05-25T04:17:41Z</dcterms:modified>
</cp:coreProperties>
</file>